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077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057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54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1861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4175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092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4133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5300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2202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975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312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7669C-FA1F-429E-B800-6D2876990625}" type="datetimeFigureOut">
              <a:rPr lang="zh-CN" altLang="en-US" smtClean="0"/>
              <a:t>2018/5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15E68-AF95-4384-AA5F-A010D8732D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756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43" y="778501"/>
            <a:ext cx="5181600" cy="447675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694217" y="5486399"/>
            <a:ext cx="92097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1. The spearman correlation between relative miR-122 content and triglyceride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3399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655580" y="5486399"/>
            <a:ext cx="9735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S2. The spearman correlation between relative miR-122 content and total cholesterol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451" y="955250"/>
            <a:ext cx="5295900" cy="4200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7486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18-05-14T01:50:02Z</dcterms:created>
  <dcterms:modified xsi:type="dcterms:W3CDTF">2018-05-14T01:51:56Z</dcterms:modified>
</cp:coreProperties>
</file>